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5" r:id="rId3"/>
    <p:sldId id="266" r:id="rId4"/>
    <p:sldId id="267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itta, Karina Silvana" initials="ZKS" lastIdx="1" clrIdx="0">
    <p:extLst>
      <p:ext uri="{19B8F6BF-5375-455C-9EA6-DF929625EA0E}">
        <p15:presenceInfo xmlns:p15="http://schemas.microsoft.com/office/powerpoint/2012/main" userId="S-1-5-21-141337351-842245563-3214328492-157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44" autoAdjust="0"/>
    <p:restoredTop sz="94660"/>
  </p:normalViewPr>
  <p:slideViewPr>
    <p:cSldViewPr snapToGrid="0">
      <p:cViewPr>
        <p:scale>
          <a:sx n="160" d="100"/>
          <a:sy n="160" d="100"/>
        </p:scale>
        <p:origin x="2047" y="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7268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4965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0542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4016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0943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4162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192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7600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659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9302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7419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54D38-7061-4512-9D43-D33598376912}" type="datetimeFigureOut">
              <a:rPr lang="de-DE" smtClean="0"/>
              <a:t>0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01FB7-C68A-491A-AF82-D67DC48E5DB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4052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BAD2D9D4-D23D-6B3D-1304-DC5CB9D2A675}"/>
              </a:ext>
            </a:extLst>
          </p:cNvPr>
          <p:cNvSpPr txBox="1"/>
          <p:nvPr/>
        </p:nvSpPr>
        <p:spPr>
          <a:xfrm>
            <a:off x="412750" y="4799013"/>
            <a:ext cx="6032500" cy="1218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. 1.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ree-way-ANOVA analysis of cell size and cell volume over time of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p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p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ultivated with (+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without the addition of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+ Co). Results are presented as mean ± standard error mean (SEM).</a:t>
            </a:r>
            <a:r>
              <a:rPr lang="en-US" sz="1000" kern="100" dirty="0">
                <a:solidFill>
                  <a:srgbClr val="FF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** P &lt; 0.01;</a:t>
            </a:r>
            <a:r>
              <a:rPr lang="en-US" sz="1000" kern="100" dirty="0">
                <a:solidFill>
                  <a:srgbClr val="FF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-way-ANOVA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7 (P4, P5, P6; HUVEC IX, HUVEC XIII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 (K281, K282, K325, K326, K327)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8 (P10, P11, P12, P13; HUVEC IX, HUVEC XIII)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 (K277, K279, K281, K282, K289, K326)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 descr="Ein Bild, das Screenshot, Design enthält.&#10;&#10;KI-generierte Inhalte können fehlerhaft sein.">
            <a:extLst>
              <a:ext uri="{FF2B5EF4-FFF2-40B4-BE49-F238E27FC236}">
                <a16:creationId xmlns:a16="http://schemas.microsoft.com/office/drawing/2014/main" id="{E5545375-97BA-DA3C-6547-A8A619650C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50" y="1522413"/>
            <a:ext cx="6032500" cy="327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7652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874E7F10-0E34-E385-DDD7-6AF74CD89A1B}"/>
              </a:ext>
            </a:extLst>
          </p:cNvPr>
          <p:cNvSpPr txBox="1"/>
          <p:nvPr/>
        </p:nvSpPr>
        <p:spPr>
          <a:xfrm>
            <a:off x="412750" y="4799012"/>
            <a:ext cx="6065872" cy="1680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. 2.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wo-way-ANOVA analysis of CD105 positive cell and qPCR analysis of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p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p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ultivated with (+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without the addition of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+ Co). Results are presented as mean ± standard error mean (SEM).</a:t>
            </a:r>
            <a:r>
              <a:rPr lang="en-US" sz="1000" kern="100" dirty="0">
                <a:solidFill>
                  <a:srgbClr val="FF0000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2-way-ANOVA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 for flow cytometric analysis (P4, P5, P6; HUVEC IX, HUVEC XIII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 (K281, K282, K325, K326, K327) and N=3 for PCR of CD105 (P4, P5; HUVEC XIII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3 (K325, K326, K327)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8 for flow cytometric analysis (P10, P11, P12, P13; HUVEC IX, HUVEC XIII)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 (K277, K279, K281, K282, K289, K326) and N=3 for PCR for CD105 (P10; HUVEC XIII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2 (K289, K326)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 descr="Ein Bild, das Screenshot, Diagramm, Rechteck, Quadrat enthält.&#10;&#10;KI-generierte Inhalte können fehlerhaft sein.">
            <a:extLst>
              <a:ext uri="{FF2B5EF4-FFF2-40B4-BE49-F238E27FC236}">
                <a16:creationId xmlns:a16="http://schemas.microsoft.com/office/drawing/2014/main" id="{E85D8F31-6BDD-F4A1-6E4B-5CFCC3FAD6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864" y="1610528"/>
            <a:ext cx="5870271" cy="31884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38133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80DC098D-1B80-E64B-68E1-82EC784DC881}"/>
              </a:ext>
            </a:extLst>
          </p:cNvPr>
          <p:cNvSpPr txBox="1"/>
          <p:nvPr/>
        </p:nvSpPr>
        <p:spPr>
          <a:xfrm>
            <a:off x="412749" y="6526032"/>
            <a:ext cx="6032501" cy="2142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. 3.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wo-way-ANOVA analysis of (</a:t>
            </a:r>
            <a:r>
              <a:rPr lang="en-US" sz="10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β-galactosidase-positive, (</a:t>
            </a:r>
            <a:r>
              <a:rPr lang="en-US" sz="10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)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ROS positive and (</a:t>
            </a:r>
            <a:r>
              <a:rPr lang="en-US" sz="10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characterization of relative intracellular changes of ROS levels in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p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p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ultivated with (+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without the addition of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+ Co). Results are presented as mean ± standard error mean (SEM). * P &lt; 0.05; ** P &lt; 0.01; 2-way-ANOVA, transformation for intracellular ROS levels: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quare root of x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csin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x)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 for flow cytometric analysis (P4, P5, P6; HUVEC IX, HUVEC XIII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 (K281, K282, K325, K326, K327) and N=3 for analysis of intracellular ROS-levels (P4, P5; HUVEC XIII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3 (K325, K326, K327)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8 for flow cytometric analysis (P10, P11, P12, P13; HUVEC IX, HUVEC XIII)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 (K277, K279, K281, K282, K289, K326) and N=3 for analysis of intracellular ROS-levels (P10; HUVEC XIII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2 (K289, K326)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Grafik 2" descr="Ein Bild, das Screenshot, Rechteck, Quadrat, Diagramm enthält.&#10;&#10;KI-generierte Inhalte können fehlerhaft sein.">
            <a:extLst>
              <a:ext uri="{FF2B5EF4-FFF2-40B4-BE49-F238E27FC236}">
                <a16:creationId xmlns:a16="http://schemas.microsoft.com/office/drawing/2014/main" id="{DBF15B3D-9BFA-BD1A-E9B9-A34A98A02D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50" y="1496832"/>
            <a:ext cx="60325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6477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691FE0C2-EE44-1225-04CC-64F6EFD0B36C}"/>
              </a:ext>
            </a:extLst>
          </p:cNvPr>
          <p:cNvSpPr txBox="1"/>
          <p:nvPr/>
        </p:nvSpPr>
        <p:spPr>
          <a:xfrm>
            <a:off x="1320421" y="7748271"/>
            <a:ext cx="4172329" cy="1680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. 4.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wo-way-ANOVA analysis of senescence associated secretory phenotype (SASP) factor protein secretion in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p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d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UVEC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lp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ultivated with (+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without the addition of </a:t>
            </a:r>
            <a:r>
              <a:rPr lang="en-US" sz="10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</a:t>
            </a:r>
            <a:r>
              <a:rPr lang="en-US" sz="1000" kern="100" baseline="-250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eg</a:t>
            </a:r>
            <a:r>
              <a:rPr lang="en-US" sz="1000" kern="100" baseline="-250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+ Co). Results are presented as mean ± standard error mean (SEM). * P &lt; 0.05; 2-way-ANOVA, transformation: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</a:rPr>
              <a:t>square root of x, </a:t>
            </a:r>
            <a:r>
              <a:rPr lang="en-US" sz="1000" dirty="0" err="1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</a:rPr>
              <a:t>arcsin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Aptos" panose="020B0004020202020204" pitchFamily="34" charset="0"/>
              </a:rPr>
              <a:t>(x)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 3 (P5, P6; HUVEC IX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2 (K281, K282);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VEC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3 (P11, P12, P13; HUVEC IX),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US" sz="10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eg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2 (K289, K326)</a:t>
            </a:r>
            <a:endParaRPr lang="de-DE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 descr="Ein Bild, das Screenshot, Rechteck, Quadrat, Software enthält.&#10;&#10;KI-generierte Inhalte können fehlerhaft sein.">
            <a:extLst>
              <a:ext uri="{FF2B5EF4-FFF2-40B4-BE49-F238E27FC236}">
                <a16:creationId xmlns:a16="http://schemas.microsoft.com/office/drawing/2014/main" id="{B5B4CE81-44A8-BA04-CC66-A0FE33ECE1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5249" y="1233171"/>
            <a:ext cx="4127500" cy="6515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5935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17</Words>
  <Application>Microsoft Office PowerPoint</Application>
  <PresentationFormat>Breitbild</PresentationFormat>
  <Paragraphs>4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brecht, Martin</dc:creator>
  <cp:lastModifiedBy>Albrecht, Martin</cp:lastModifiedBy>
  <cp:revision>9</cp:revision>
  <dcterms:created xsi:type="dcterms:W3CDTF">2025-12-02T11:20:39Z</dcterms:created>
  <dcterms:modified xsi:type="dcterms:W3CDTF">2026-01-05T11:17:54Z</dcterms:modified>
</cp:coreProperties>
</file>